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00C885-108B-4C0B-AB2C-8F27ACC8197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20C369-2460-4DFC-AD20-20F1A8A3BD8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A80D99-C93A-47AA-AD86-7D778E3CDEF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506FAD-7311-473C-A92B-D99838F9784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49AF1D-CB58-4AE8-BF88-167E35DD8BC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E07B62-6BCA-4FCF-A997-1267CEE65AC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10FD67-7A50-4768-A195-261E99EE0F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385FB9-4225-4DD4-81A0-93077FFC0D5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4E1193-E0E5-4ED8-A62D-EE7CE1A6443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7A433A-6899-427E-9DCE-84FC0405BD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BCB828-F05A-4614-9738-04127D1748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26FE20-FC8E-496E-A41D-4B20EDCE58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843E92E-786C-4F7C-A950-8E6557C3244D}" type="slidenum">
              <a:rPr b="0" lang="en-CA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656"/>
          <p:cNvSpPr/>
          <p:nvPr/>
        </p:nvSpPr>
        <p:spPr>
          <a:xfrm>
            <a:off x="747360" y="6313320"/>
            <a:ext cx="256284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before trastuzumab-based treatmen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                     </a:t>
            </a: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(patient #4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656"/>
          <p:cNvSpPr/>
          <p:nvPr/>
        </p:nvSpPr>
        <p:spPr>
          <a:xfrm>
            <a:off x="3987720" y="6313320"/>
            <a:ext cx="24606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after trastuzumab-based treatmen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                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(patient #4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656"/>
          <p:cNvSpPr/>
          <p:nvPr/>
        </p:nvSpPr>
        <p:spPr>
          <a:xfrm>
            <a:off x="285840" y="3059280"/>
            <a:ext cx="52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H&amp;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656"/>
          <p:cNvSpPr/>
          <p:nvPr/>
        </p:nvSpPr>
        <p:spPr>
          <a:xfrm>
            <a:off x="312840" y="4906800"/>
            <a:ext cx="4856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anti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Irf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656"/>
          <p:cNvSpPr/>
          <p:nvPr/>
        </p:nvSpPr>
        <p:spPr>
          <a:xfrm>
            <a:off x="550800" y="220968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656"/>
          <p:cNvSpPr/>
          <p:nvPr/>
        </p:nvSpPr>
        <p:spPr>
          <a:xfrm>
            <a:off x="3625200" y="219564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656"/>
          <p:cNvSpPr/>
          <p:nvPr/>
        </p:nvSpPr>
        <p:spPr>
          <a:xfrm>
            <a:off x="551520" y="4152960"/>
            <a:ext cx="247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656"/>
          <p:cNvSpPr/>
          <p:nvPr/>
        </p:nvSpPr>
        <p:spPr>
          <a:xfrm>
            <a:off x="3646080" y="41529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Picture 10" descr=""/>
          <p:cNvPicPr/>
          <p:nvPr/>
        </p:nvPicPr>
        <p:blipFill>
          <a:blip r:embed="rId1"/>
          <a:stretch/>
        </p:blipFill>
        <p:spPr>
          <a:xfrm>
            <a:off x="816120" y="4356000"/>
            <a:ext cx="2428560" cy="191952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31" descr=""/>
          <p:cNvPicPr/>
          <p:nvPr/>
        </p:nvPicPr>
        <p:blipFill>
          <a:blip r:embed="rId2"/>
          <a:stretch/>
        </p:blipFill>
        <p:spPr>
          <a:xfrm>
            <a:off x="3911760" y="4356000"/>
            <a:ext cx="2428560" cy="192096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15" descr="A fabric surface&#10;&#10;Description generated with high confidence"/>
          <p:cNvPicPr/>
          <p:nvPr/>
        </p:nvPicPr>
        <p:blipFill>
          <a:blip r:embed="rId3"/>
          <a:stretch/>
        </p:blipFill>
        <p:spPr>
          <a:xfrm>
            <a:off x="816120" y="2338560"/>
            <a:ext cx="2422440" cy="191736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38" descr="A picture containing clothing, indoor&#10;&#10;Description generated with very high confidence"/>
          <p:cNvPicPr/>
          <p:nvPr/>
        </p:nvPicPr>
        <p:blipFill>
          <a:blip r:embed="rId4"/>
          <a:stretch/>
        </p:blipFill>
        <p:spPr>
          <a:xfrm>
            <a:off x="3911760" y="2338560"/>
            <a:ext cx="2414520" cy="1911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3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9-19T18:51:13Z</dcterms:created>
  <dc:creator>krosen</dc:creator>
  <dc:description/>
  <dc:language>en-US</dc:language>
  <cp:lastModifiedBy>kirill.rosen@hotmail.com</cp:lastModifiedBy>
  <dcterms:modified xsi:type="dcterms:W3CDTF">2018-10-18T19:31:19Z</dcterms:modified>
  <cp:revision>94</cp:revision>
  <dc:subject/>
  <dc:title>Slide 1</dc:title>
</cp:coreProperties>
</file>